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8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6</a:t>
            </a:r>
          </a:p>
        </p:txBody>
      </p:sp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286531" y="982701"/>
            <a:ext cx="4366900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Unadjusted 1</a:t>
            </a:r>
            <a:r>
              <a:rPr lang="en-US" sz="1400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 line treatment-TMB interaction models from Supplemental Figure 3.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The (A) TTNT and (B) OS interaction models are shown for for propensity adjusted analyses in Supplemental Figure 3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08C7FA-82EC-2044-91F9-0227F815F58E}"/>
              </a:ext>
            </a:extLst>
          </p:cNvPr>
          <p:cNvSpPr txBox="1"/>
          <p:nvPr/>
        </p:nvSpPr>
        <p:spPr>
          <a:xfrm>
            <a:off x="5581038" y="490654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9C30823-36CD-0A4A-A9F2-C547B7D5334B}"/>
              </a:ext>
            </a:extLst>
          </p:cNvPr>
          <p:cNvSpPr txBox="1"/>
          <p:nvPr/>
        </p:nvSpPr>
        <p:spPr>
          <a:xfrm>
            <a:off x="5581038" y="1892747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D879E0E8-D48D-8742-9FFF-1F6E5B61ADCD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490654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2.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3.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22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0B196205-2ABA-CD42-9DB9-20FC4E5491B3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1869688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2.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2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9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92809460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92</Words>
  <Application>Microsoft Macintosh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6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9</cp:revision>
  <dcterms:created xsi:type="dcterms:W3CDTF">2022-06-12T16:24:02Z</dcterms:created>
  <dcterms:modified xsi:type="dcterms:W3CDTF">2022-08-13T14:34:20Z</dcterms:modified>
</cp:coreProperties>
</file>